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2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361"/>
    <p:restoredTop sz="94694"/>
  </p:normalViewPr>
  <p:slideViewPr>
    <p:cSldViewPr snapToGrid="0" snapToObjects="1">
      <p:cViewPr>
        <p:scale>
          <a:sx n="190" d="100"/>
          <a:sy n="190" d="100"/>
        </p:scale>
        <p:origin x="132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A856B9-DF08-4341-8434-23BC0A0F7DA1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CE27A1-F44C-5D4F-9D5D-64F3C879E81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825839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CE27A1-F44C-5D4F-9D5D-64F3C879E817}" type="slidenum">
              <a:rPr kumimoji="1" lang="zh-CN" altLang="en-US" smtClean="0"/>
              <a:t>1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044095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将图片拖动到占位符，或单击添加图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29495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A69DB6A1-CCF6-75CD-5BCA-4B968358F0F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87112874"/>
              </p:ext>
            </p:extLst>
          </p:nvPr>
        </p:nvGraphicFramePr>
        <p:xfrm>
          <a:off x="732155" y="1471296"/>
          <a:ext cx="5391785" cy="15240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76960">
                  <a:extLst>
                    <a:ext uri="{9D8B030D-6E8A-4147-A177-3AD203B41FA5}">
                      <a16:colId xmlns:a16="http://schemas.microsoft.com/office/drawing/2014/main" val="154197658"/>
                    </a:ext>
                  </a:extLst>
                </a:gridCol>
                <a:gridCol w="2162175">
                  <a:extLst>
                    <a:ext uri="{9D8B030D-6E8A-4147-A177-3AD203B41FA5}">
                      <a16:colId xmlns:a16="http://schemas.microsoft.com/office/drawing/2014/main" val="2716401394"/>
                    </a:ext>
                  </a:extLst>
                </a:gridCol>
                <a:gridCol w="2152650">
                  <a:extLst>
                    <a:ext uri="{9D8B030D-6E8A-4147-A177-3AD203B41FA5}">
                      <a16:colId xmlns:a16="http://schemas.microsoft.com/office/drawing/2014/main" val="107524079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071986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vcr1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" altLang="ja-JP" sz="10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ACGGCTAACCAGAGTGACTT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" altLang="ja-JP" sz="10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ACCACCCCCTTCACTACTTC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612458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TCTCTGCTCCTCCCTGT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CGTTGAACTTGCCGTGGG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46862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CCCGCGAGTACAACCTTCTTG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CTCTTGCTCTGGGCCTCGT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6753559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DH2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GGTGTGACAACCCTTGAC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TTGGGGGTACACTGAGA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2229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trate synthase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GCAGCTCTCTCTCTCCGA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GACGAGGCAGGATGAGTT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613943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H2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ATGGCGATGAGATGACCC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GTCATTGGTCTGGTCACG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488856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HA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CGGGCCACTCACTCTTAC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CAGTGCAATGACACCACG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001648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marase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GACGCTGTCCCTCTTACT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CAGCGAGCTCGTAGATTC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200909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altLang="ja-JP" sz="1000" b="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-</a:t>
                      </a:r>
                      <a:r>
                        <a:rPr lang="en-US" altLang="ja-JP" sz="1000" b="0" kern="100" dirty="0" err="1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yc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" altLang="ja-JP" sz="10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GAAAAGAGCTCCTCGCGTT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" altLang="ja-JP" sz="10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AATAGGGCTGCACCGAGTC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08424832"/>
                  </a:ext>
                </a:extLst>
              </a:tr>
            </a:tbl>
          </a:graphicData>
        </a:graphic>
      </p:graphicFrame>
      <p:sp>
        <p:nvSpPr>
          <p:cNvPr id="4" name="Rectangle 1">
            <a:extLst>
              <a:ext uri="{FF2B5EF4-FFF2-40B4-BE49-F238E27FC236}">
                <a16:creationId xmlns:a16="http://schemas.microsoft.com/office/drawing/2014/main" id="{1C2CB0CF-F761-D366-9D35-00B4F6D57D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4060" y="818128"/>
            <a:ext cx="2707793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 Table</a:t>
            </a:r>
            <a:r>
              <a:rPr kumimoji="0" lang="en-US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Primers</a:t>
            </a: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 used in this study</a:t>
            </a:r>
            <a:endParaRPr kumimoji="0" lang="ja-JP" altLang="ja-JP" sz="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11811345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56</TotalTime>
  <Words>40</Words>
  <Application>Microsoft Macintosh PowerPoint</Application>
  <PresentationFormat>A4 210 x 297 mm</PresentationFormat>
  <Paragraphs>3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DengXian</vt:lpstr>
      <vt:lpstr>游明朝</vt:lpstr>
      <vt:lpstr>Arial</vt:lpstr>
      <vt:lpstr>Calibri</vt:lpstr>
      <vt:lpstr>Calibri Light</vt:lpstr>
      <vt:lpstr>Times New Roman</vt:lpstr>
      <vt:lpstr>Office 主题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en ShH</dc:creator>
  <cp:lastModifiedBy>秋 利彦</cp:lastModifiedBy>
  <cp:revision>378</cp:revision>
  <dcterms:created xsi:type="dcterms:W3CDTF">2021-09-17T03:00:21Z</dcterms:created>
  <dcterms:modified xsi:type="dcterms:W3CDTF">2024-06-30T05:01:01Z</dcterms:modified>
</cp:coreProperties>
</file>